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26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3740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442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4709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275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5631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0080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8793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8631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352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9616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6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0949D-699C-4D2D-B1E9-070D5BFBD15C}" type="datetimeFigureOut">
              <a:rPr lang="zh-CN" altLang="en-US" smtClean="0"/>
              <a:t>2023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43E43-EEB5-49FB-B319-5ECDEE4392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4980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tif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61257" y="117564"/>
            <a:ext cx="2899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61257" y="496019"/>
            <a:ext cx="326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834642" y="5519512"/>
            <a:ext cx="326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83026" y="5519512"/>
            <a:ext cx="326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4312413"/>
              </p:ext>
            </p:extLst>
          </p:nvPr>
        </p:nvGraphicFramePr>
        <p:xfrm>
          <a:off x="587826" y="5519512"/>
          <a:ext cx="1979613" cy="317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Prism 8" r:id="rId3" imgW="1978946" imgH="3177279" progId="Prism8.Document">
                  <p:embed/>
                </p:oleObj>
              </mc:Choice>
              <mc:Fallback>
                <p:oleObj name="Prism 8" r:id="rId3" imgW="1978946" imgH="3177279" progId="Prism8.Document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87826" y="5519512"/>
                        <a:ext cx="1979613" cy="3176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8911274"/>
              </p:ext>
            </p:extLst>
          </p:nvPr>
        </p:nvGraphicFramePr>
        <p:xfrm>
          <a:off x="3161211" y="5519512"/>
          <a:ext cx="1979613" cy="317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Prism 8" r:id="rId5" imgW="1978946" imgH="3177279" progId="Prism8.Document">
                  <p:embed/>
                </p:oleObj>
              </mc:Choice>
              <mc:Fallback>
                <p:oleObj name="Prism 8" r:id="rId5" imgW="1978946" imgH="3177279" progId="Prism8.Document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61211" y="5519512"/>
                        <a:ext cx="1979613" cy="3176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6" name="组合 45"/>
          <p:cNvGrpSpPr/>
          <p:nvPr/>
        </p:nvGrpSpPr>
        <p:grpSpPr>
          <a:xfrm>
            <a:off x="777240" y="3074292"/>
            <a:ext cx="4114801" cy="2314184"/>
            <a:chOff x="777240" y="3074292"/>
            <a:chExt cx="4114801" cy="2314184"/>
          </a:xfrm>
        </p:grpSpPr>
        <p:pic>
          <p:nvPicPr>
            <p:cNvPr id="6" name="图片 5"/>
            <p:cNvPicPr preferRelativeResize="0"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7241" y="3074292"/>
              <a:ext cx="4114800" cy="2314184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27" name="文本框 26"/>
            <p:cNvSpPr txBox="1"/>
            <p:nvPr/>
          </p:nvSpPr>
          <p:spPr>
            <a:xfrm>
              <a:off x="777240" y="3074292"/>
              <a:ext cx="7857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404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接连接符 27"/>
            <p:cNvCxnSpPr/>
            <p:nvPr/>
          </p:nvCxnSpPr>
          <p:spPr>
            <a:xfrm>
              <a:off x="1732398" y="4180254"/>
              <a:ext cx="542969" cy="290737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/>
            <p:cNvCxnSpPr/>
            <p:nvPr/>
          </p:nvCxnSpPr>
          <p:spPr>
            <a:xfrm flipV="1">
              <a:off x="3161211" y="4364666"/>
              <a:ext cx="235891" cy="21363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>
              <a:off x="3074736" y="4679240"/>
              <a:ext cx="237306" cy="7087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/>
            <p:cNvSpPr txBox="1"/>
            <p:nvPr/>
          </p:nvSpPr>
          <p:spPr>
            <a:xfrm rot="1758924">
              <a:off x="1795326" y="4174509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&gt;5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 rot="21384237">
              <a:off x="3095689" y="4352823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93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2988866" y="4658785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74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318361" y="3685436"/>
              <a:ext cx="78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26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271070" y="4049218"/>
              <a:ext cx="78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404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2820287" y="4884548"/>
              <a:ext cx="78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e420</a:t>
              </a:r>
            </a:p>
          </p:txBody>
        </p:sp>
      </p:grpSp>
      <p:grpSp>
        <p:nvGrpSpPr>
          <p:cNvPr id="45" name="组合 44"/>
          <p:cNvGrpSpPr/>
          <p:nvPr/>
        </p:nvGrpSpPr>
        <p:grpSpPr>
          <a:xfrm>
            <a:off x="777241" y="644600"/>
            <a:ext cx="4114801" cy="2314184"/>
            <a:chOff x="777241" y="644600"/>
            <a:chExt cx="4114801" cy="2314184"/>
          </a:xfrm>
        </p:grpSpPr>
        <p:pic>
          <p:nvPicPr>
            <p:cNvPr id="5" name="图片 4"/>
            <p:cNvPicPr preferRelativeResize="0"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7241" y="644600"/>
              <a:ext cx="4114801" cy="2314184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cxnSp>
          <p:nvCxnSpPr>
            <p:cNvPr id="14" name="直接连接符 13"/>
            <p:cNvCxnSpPr/>
            <p:nvPr/>
          </p:nvCxnSpPr>
          <p:spPr>
            <a:xfrm flipV="1">
              <a:off x="2466753" y="1679944"/>
              <a:ext cx="100686" cy="37214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/>
            <p:cNvCxnSpPr/>
            <p:nvPr/>
          </p:nvCxnSpPr>
          <p:spPr>
            <a:xfrm flipV="1">
              <a:off x="2231064" y="1903228"/>
              <a:ext cx="384545" cy="171962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>
              <a:off x="2834641" y="1940442"/>
              <a:ext cx="498666" cy="244549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/>
            <p:nvPr/>
          </p:nvCxnSpPr>
          <p:spPr>
            <a:xfrm>
              <a:off x="3290777" y="1801692"/>
              <a:ext cx="303028" cy="23242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/>
            <p:cNvSpPr txBox="1"/>
            <p:nvPr/>
          </p:nvSpPr>
          <p:spPr>
            <a:xfrm rot="20406097">
              <a:off x="2329593" y="1514544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40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 rot="20161347">
              <a:off x="2170811" y="1818348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43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 rot="1564233">
              <a:off x="2942070" y="1970384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81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 rot="223315">
              <a:off x="3225141" y="1650578"/>
              <a:ext cx="5050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91Å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777241" y="644600"/>
              <a:ext cx="7857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391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654977" y="2265879"/>
              <a:ext cx="78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u387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2416515" y="1987902"/>
              <a:ext cx="78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391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3161211" y="2525432"/>
              <a:ext cx="785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e395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7" name="文本框 46"/>
          <p:cNvSpPr txBox="1"/>
          <p:nvPr/>
        </p:nvSpPr>
        <p:spPr>
          <a:xfrm>
            <a:off x="283025" y="8602579"/>
            <a:ext cx="618996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A) Protein structure remodeling of FARSA mutations Pro391 and His404 using Phyre</a:t>
            </a:r>
            <a:r>
              <a:rPr lang="en-US" altLang="zh-CN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protein fold recognition server. The space between Pro391 and Leu387 was as close as 1.4Å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FARSA chain is </a:t>
            </a:r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colored </a:t>
            </a:r>
            <a:r>
              <a:rPr lang="en-US" altLang="zh-CN" sz="1100" smtClean="0">
                <a:latin typeface="Arial" panose="020B0604020202020204" pitchFamily="34" charset="0"/>
                <a:cs typeface="Arial" panose="020B0604020202020204" pitchFamily="34" charset="0"/>
              </a:rPr>
              <a:t>light yellow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nd FARSB chain is colored light gray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(B and C) The protein expression levels of FARSA and FARSB in the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roband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and his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arents. The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verage protein expression levels of his parents were used as normal control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62186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61257" y="117564"/>
            <a:ext cx="2899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lum bright="40000" contrast="40000"/>
          </a:blip>
          <a:stretch>
            <a:fillRect/>
          </a:stretch>
        </p:blipFill>
        <p:spPr>
          <a:xfrm>
            <a:off x="269157" y="1119615"/>
            <a:ext cx="1614987" cy="301412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lum bright="40000" contrast="40000"/>
          </a:blip>
          <a:stretch>
            <a:fillRect/>
          </a:stretch>
        </p:blipFill>
        <p:spPr>
          <a:xfrm>
            <a:off x="2302269" y="1119615"/>
            <a:ext cx="1614987" cy="3014127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13506" y="781061"/>
            <a:ext cx="326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202581" y="781061"/>
            <a:ext cx="326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069081" y="781061"/>
            <a:ext cx="326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61256" y="4466379"/>
            <a:ext cx="646439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A, B and C) Original full uncropped blots with membrane edges and markers of FARSA, FARSB and  </a:t>
            </a:r>
            <a:r>
              <a:rPr lang="el-GR" altLang="zh-CN" sz="1100" dirty="0" smtClean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β</a:t>
            </a:r>
            <a:r>
              <a:rPr lang="en-US" altLang="zh-CN" sz="1100" dirty="0" smtClean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Actin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27279" y="1119615"/>
            <a:ext cx="1614987" cy="3014127"/>
          </a:xfrm>
          <a:prstGeom prst="rect">
            <a:avLst/>
          </a:prstGeom>
        </p:spPr>
      </p:pic>
      <p:cxnSp>
        <p:nvCxnSpPr>
          <p:cNvPr id="13" name="直接连接符 12"/>
          <p:cNvCxnSpPr/>
          <p:nvPr/>
        </p:nvCxnSpPr>
        <p:spPr>
          <a:xfrm>
            <a:off x="1659436" y="1660358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1659436" y="1860885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1659436" y="2161674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>
            <a:off x="1659436" y="2426369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1659436" y="2739190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1659436" y="2999877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1659436" y="3288634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3750068" y="1660358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3750068" y="1876923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3750068" y="2189746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3750068" y="2462464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3750068" y="2739189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3750068" y="3052012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3750068" y="3296655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4014710" y="1535878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014710" y="1772514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4014710" y="2061118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014710" y="2344537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014710" y="2623514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014710" y="2936336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014710" y="3188998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1944125" y="1532139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1944125" y="1768775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1944125" y="2057379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1944125" y="2340798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1944125" y="2619775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1944125" y="2932597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1944125" y="3185259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/>
          <p:cNvCxnSpPr/>
          <p:nvPr/>
        </p:nvCxnSpPr>
        <p:spPr>
          <a:xfrm>
            <a:off x="6024036" y="1507839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/>
        </p:nvCxnSpPr>
        <p:spPr>
          <a:xfrm>
            <a:off x="6024036" y="1724404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连接符 60"/>
          <p:cNvCxnSpPr/>
          <p:nvPr/>
        </p:nvCxnSpPr>
        <p:spPr>
          <a:xfrm>
            <a:off x="6024036" y="2037227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6024036" y="2309945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>
            <a:off x="6024036" y="2586670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/>
        </p:nvCxnSpPr>
        <p:spPr>
          <a:xfrm>
            <a:off x="6024036" y="2899493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>
            <a:off x="6024036" y="3144136"/>
            <a:ext cx="3162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6288678" y="1383359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6288678" y="1619995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6288678" y="1908599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6288678" y="2192018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6288678" y="2470995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6288678" y="2783817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6288678" y="3036479"/>
            <a:ext cx="553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0307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152</Words>
  <Application>Microsoft Office PowerPoint</Application>
  <PresentationFormat>A4 纸张(210x297 毫米)</PresentationFormat>
  <Paragraphs>46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Office 主题​​</vt:lpstr>
      <vt:lpstr>Prism 8</vt:lpstr>
      <vt:lpstr>PowerPoint 演示文稿</vt:lpstr>
      <vt:lpstr>PowerPoint 演示文稿</vt:lpstr>
    </vt:vector>
  </TitlesOfParts>
  <Company>神州网信技术有限公司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28</cp:revision>
  <dcterms:created xsi:type="dcterms:W3CDTF">2023-08-18T06:25:49Z</dcterms:created>
  <dcterms:modified xsi:type="dcterms:W3CDTF">2023-08-18T08:13:48Z</dcterms:modified>
</cp:coreProperties>
</file>